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61318" autoAdjust="0"/>
  </p:normalViewPr>
  <p:slideViewPr>
    <p:cSldViewPr>
      <p:cViewPr varScale="1">
        <p:scale>
          <a:sx n="77" d="100"/>
          <a:sy n="77" d="100"/>
        </p:scale>
        <p:origin x="3184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6EAC0D-FAC5-4BBB-884B-7A90EBBFC7BC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1F3736-C0FD-4D27-987D-D3D488C2E2D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656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81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3445225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ULSSR258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0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5075625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oSo-157-2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10074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3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9005517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1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399462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ULSSR85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8299536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ULSSR96B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308094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10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383057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89A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7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578839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107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8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4820682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82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1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86658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oSO340-2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5018580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20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20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16512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87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77125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oSo288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740746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ULSSR253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470679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2SSR112A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837150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MULSSR2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DF8801-6853-45DF-A6E1-BBFB586B2807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49251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baseline="0" dirty="0"/>
              <a:t>M2SSR68</a:t>
            </a:r>
            <a:endParaRPr lang="en-US" b="1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DF8801-6853-45DF-A6E1-BBFB586B2807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17160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MULSSR313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1. Dharatwala, 2. Madhopur-1, 3. Hairythick, 4. M. laevigata (Hybrid), 5. </a:t>
            </a:r>
            <a:r>
              <a:rPr lang="en-US" dirty="0" err="1"/>
              <a:t>M.lhouseringe</a:t>
            </a:r>
            <a:r>
              <a:rPr lang="en-US" dirty="0"/>
              <a:t>, 6. Kokuso-20, 7. Belona, 8. Jai Ram </a:t>
            </a:r>
            <a:r>
              <a:rPr lang="en-US" dirty="0" err="1"/>
              <a:t>Sanehi</a:t>
            </a:r>
            <a:r>
              <a:rPr lang="en-US" dirty="0"/>
              <a:t> </a:t>
            </a:r>
            <a:r>
              <a:rPr lang="en-US" dirty="0" err="1"/>
              <a:t>Bagichi</a:t>
            </a:r>
            <a:r>
              <a:rPr lang="en-US" dirty="0"/>
              <a:t> </a:t>
            </a:r>
            <a:r>
              <a:rPr lang="en-US" dirty="0" err="1"/>
              <a:t>Uj</a:t>
            </a:r>
            <a:r>
              <a:rPr lang="en-US" dirty="0"/>
              <a:t>, 9. Nalhdwara-1, 10. Ranchi-1 11. Birds Foot, 12. Nao Khurkul, 13. Veterinary College, 14. Lava Forest-1, 15. New Delhi, 16. UP-22, 17. English Black, 18. Seekupari, 19. KNG, 20. V1 diploid, 21. S-1, 22. Pouri-1,  23. Jabalpur, 24. Saranath-1, 25. S-642, 26. Chandrapuri , 27. Palampur Local, 28.  Assama Bola, 29. Nowshera-1, 30. Sabbawala-2, 31. Jalalgarah-3, 32. Bagaban Masijd, 33. Naudan-1, 34. Vadapuram, 35. Churai Mohal, 36. School Salem, 37. Sujanpur-5, 38. RC-1, 39. Bonniampadi, 40. S13 diploid, 41. S-36 42. Thattahalli Village -1, 43. S-34 , 44. Thandikudi , 45. S-30, 46. Palsana-3, 47. Haridwar-4, 48.  </a:t>
            </a:r>
            <a:r>
              <a:rPr lang="en-US" dirty="0" err="1"/>
              <a:t>Keeraithodu</a:t>
            </a:r>
            <a:r>
              <a:rPr lang="en-US" dirty="0"/>
              <a:t>, 49. Gumla-6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CA022E1-51CA-444F-9F9E-580809AC2600}" type="slidenum">
              <a:rPr lang="en-IN" smtClean="0"/>
              <a:pPr/>
              <a:t>9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799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/>
          <a:srcRect l="11026" r="5897" b="28267"/>
          <a:stretch>
            <a:fillRect/>
          </a:stretch>
        </p:blipFill>
        <p:spPr bwMode="auto">
          <a:xfrm>
            <a:off x="381000" y="228600"/>
            <a:ext cx="7848600" cy="464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7"/>
          <p:cNvSpPr/>
          <p:nvPr/>
        </p:nvSpPr>
        <p:spPr>
          <a:xfrm>
            <a:off x="457200" y="228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9" name="Rectangle 8"/>
          <p:cNvSpPr/>
          <p:nvPr/>
        </p:nvSpPr>
        <p:spPr>
          <a:xfrm>
            <a:off x="457200" y="2514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37 38 39 40 41 42 43 44 45 46 47 48 49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8974" r="7949" b="34450"/>
          <a:stretch>
            <a:fillRect/>
          </a:stretch>
        </p:blipFill>
        <p:spPr bwMode="auto">
          <a:xfrm>
            <a:off x="533400" y="762000"/>
            <a:ext cx="7924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6858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 13 14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 cstate="print"/>
          <a:srcRect l="7179" r="8718" b="34146"/>
          <a:stretch>
            <a:fillRect/>
          </a:stretch>
        </p:blipFill>
        <p:spPr bwMode="auto">
          <a:xfrm>
            <a:off x="609600" y="990600"/>
            <a:ext cx="7924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Rectangle 9"/>
          <p:cNvSpPr/>
          <p:nvPr/>
        </p:nvSpPr>
        <p:spPr>
          <a:xfrm>
            <a:off x="685800" y="9144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1   2   3    4   5   6   7   8     9  10  11 12  L   13 14 15 16 17 18 19 20 21 22 23 24  25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858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26 27 28 29 30 31 32 33 34  35  36 37  38 39 40   L   41 42 43  44 45 46 47 48 49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1026" r="4872" b="30029"/>
          <a:stretch>
            <a:fillRect/>
          </a:stretch>
        </p:blipFill>
        <p:spPr bwMode="auto">
          <a:xfrm>
            <a:off x="533400" y="685800"/>
            <a:ext cx="78486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6858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895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37 38 39 40 41 42 43 44 45 46 47 48 49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 cstate="print"/>
          <a:srcRect l="8974" t="34359" r="7949" b="49689"/>
          <a:stretch>
            <a:fillRect/>
          </a:stretch>
        </p:blipFill>
        <p:spPr bwMode="auto">
          <a:xfrm>
            <a:off x="533400" y="2362200"/>
            <a:ext cx="79248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8974" r="7949" b="87729"/>
          <a:stretch>
            <a:fillRect/>
          </a:stretch>
        </p:blipFill>
        <p:spPr bwMode="auto">
          <a:xfrm>
            <a:off x="533400" y="914400"/>
            <a:ext cx="79248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533400" y="8382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1026" r="6923" b="32131"/>
          <a:stretch>
            <a:fillRect/>
          </a:stretch>
        </p:blipFill>
        <p:spPr bwMode="auto">
          <a:xfrm>
            <a:off x="609600" y="838199"/>
            <a:ext cx="7924800" cy="426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7620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7620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5897" r="11026" b="31769"/>
          <a:stretch>
            <a:fillRect/>
          </a:stretch>
        </p:blipFill>
        <p:spPr bwMode="auto">
          <a:xfrm>
            <a:off x="457200" y="838199"/>
            <a:ext cx="7924800" cy="41910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457200" y="7620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5334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40000"/>
          </a:blip>
          <a:srcRect l="8974" r="7949" b="44304"/>
          <a:stretch>
            <a:fillRect/>
          </a:stretch>
        </p:blipFill>
        <p:spPr bwMode="auto">
          <a:xfrm>
            <a:off x="609600" y="990600"/>
            <a:ext cx="7848600" cy="335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9144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85800" y="27432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0000" r="7949" b="32076"/>
          <a:stretch>
            <a:fillRect/>
          </a:stretch>
        </p:blipFill>
        <p:spPr bwMode="auto">
          <a:xfrm>
            <a:off x="533400" y="761999"/>
            <a:ext cx="7772400" cy="4038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533400" y="8382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6923" r="10000" b="35443"/>
          <a:stretch>
            <a:fillRect/>
          </a:stretch>
        </p:blipFill>
        <p:spPr bwMode="auto">
          <a:xfrm>
            <a:off x="533400" y="838200"/>
            <a:ext cx="7848600" cy="388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533400" y="762000"/>
            <a:ext cx="78486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1   2   3    4   5   6   7   8     9  10  11 12  13 14  15    L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5908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5897" r="10000"/>
          <a:stretch>
            <a:fillRect/>
          </a:stretch>
        </p:blipFill>
        <p:spPr bwMode="auto">
          <a:xfrm>
            <a:off x="533400" y="914400"/>
            <a:ext cx="79248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990599"/>
            <a:ext cx="7772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1    2   3   4    5   6    7    8   9  10 11 12   L  13 14 15 16 17 18 19 20 21 22 23 24 25</a:t>
            </a:r>
          </a:p>
        </p:txBody>
      </p:sp>
      <p:sp>
        <p:nvSpPr>
          <p:cNvPr id="7" name="Rectangle 6"/>
          <p:cNvSpPr/>
          <p:nvPr/>
        </p:nvSpPr>
        <p:spPr>
          <a:xfrm>
            <a:off x="685800" y="3047999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26 27 28 29 30 31 32 33 34 35  36   37 38 39 40  L   41 42 43 44 45 46 47 48 49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40000"/>
          </a:blip>
          <a:srcRect l="5897" r="11026" b="33275"/>
          <a:stretch>
            <a:fillRect/>
          </a:stretch>
        </p:blipFill>
        <p:spPr bwMode="auto">
          <a:xfrm>
            <a:off x="533400" y="762000"/>
            <a:ext cx="7888192" cy="449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762000"/>
            <a:ext cx="7772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1   2   3   4   5   6   7   8     9  10  11 12   13 14 15 16 L   17 18 19 20 21 22 23  24 25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85800" y="32004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6 27 28 29 30 31 32 33 34 35  36   37   38 39 40 41 42 43 44 45 46 47 48 49   L</a:t>
            </a: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6923" t="48606" r="8974" b="30488"/>
          <a:stretch>
            <a:fillRect/>
          </a:stretch>
        </p:blipFill>
        <p:spPr bwMode="auto">
          <a:xfrm>
            <a:off x="533400" y="2514600"/>
            <a:ext cx="7914640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 cstate="print"/>
          <a:srcRect l="6923" r="8974" b="75087"/>
          <a:stretch>
            <a:fillRect/>
          </a:stretch>
        </p:blipFill>
        <p:spPr bwMode="auto">
          <a:xfrm>
            <a:off x="533400" y="838200"/>
            <a:ext cx="7924800" cy="17275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Rectangle 6"/>
          <p:cNvSpPr/>
          <p:nvPr/>
        </p:nvSpPr>
        <p:spPr>
          <a:xfrm>
            <a:off x="685800" y="914400"/>
            <a:ext cx="77724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1   2   3   4   5   6   7   8     9  10  11 12    L  13 14 15 16 17 18 19 20 21 22 23  24 25  </a:t>
            </a:r>
          </a:p>
        </p:txBody>
      </p:sp>
      <p:sp>
        <p:nvSpPr>
          <p:cNvPr id="8" name="Rectangle 7"/>
          <p:cNvSpPr/>
          <p:nvPr/>
        </p:nvSpPr>
        <p:spPr>
          <a:xfrm>
            <a:off x="685800" y="24384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6 27 28 29 30 31 32 33 34 35  36   37 L   38 39 40 41 42 43 44 45 46 47 48 49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-20000"/>
          </a:blip>
          <a:srcRect l="10256" r="7692" b="35633"/>
          <a:stretch>
            <a:fillRect/>
          </a:stretch>
        </p:blipFill>
        <p:spPr bwMode="auto">
          <a:xfrm>
            <a:off x="609600" y="838438"/>
            <a:ext cx="7696200" cy="4266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8382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1   2   3    4   5   6   7   8     9  10  11 12 13 14 15  L 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30480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37  L   38 39 40 41 42 43 44 45 46 47 48 49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7949" t="-174" r="8974" b="32672"/>
          <a:stretch>
            <a:fillRect/>
          </a:stretch>
        </p:blipFill>
        <p:spPr bwMode="auto">
          <a:xfrm>
            <a:off x="685800" y="838200"/>
            <a:ext cx="7696200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8382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85800" y="30480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37 38 39 40 41 42 43 44 45 46 47 48 49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>
            <a:lum bright="-10000" contrast="32000"/>
          </a:blip>
          <a:srcRect l="8974" r="6923" b="31664"/>
          <a:stretch>
            <a:fillRect/>
          </a:stretch>
        </p:blipFill>
        <p:spPr bwMode="auto">
          <a:xfrm>
            <a:off x="609600" y="990600"/>
            <a:ext cx="7772400" cy="4419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Rectangle 8"/>
          <p:cNvSpPr/>
          <p:nvPr/>
        </p:nvSpPr>
        <p:spPr>
          <a:xfrm>
            <a:off x="609600" y="990601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10" name="Rectangle 9"/>
          <p:cNvSpPr/>
          <p:nvPr/>
        </p:nvSpPr>
        <p:spPr>
          <a:xfrm>
            <a:off x="685800" y="3352801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37 38 39 40 41 42 43 44 45 46 47 48 49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0000" r="5897" b="37444"/>
          <a:stretch>
            <a:fillRect/>
          </a:stretch>
        </p:blipFill>
        <p:spPr bwMode="auto">
          <a:xfrm>
            <a:off x="533400" y="838199"/>
            <a:ext cx="7848600" cy="39624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7620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   L 13 14 15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6670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 l="6505" t="2870" r="11026" b="29126"/>
          <a:stretch>
            <a:fillRect/>
          </a:stretch>
        </p:blipFill>
        <p:spPr bwMode="auto">
          <a:xfrm>
            <a:off x="762000" y="762000"/>
            <a:ext cx="7696200" cy="4670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762000" y="860154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6" name="Rectangle 5"/>
          <p:cNvSpPr/>
          <p:nvPr/>
        </p:nvSpPr>
        <p:spPr>
          <a:xfrm>
            <a:off x="762000" y="3222354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L  37 38 39 40 41 42 43 44 45 46 47 48 49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6358" r="10983" b="29966"/>
          <a:stretch>
            <a:fillRect/>
          </a:stretch>
        </p:blipFill>
        <p:spPr bwMode="auto">
          <a:xfrm>
            <a:off x="685800" y="703800"/>
            <a:ext cx="7676000" cy="463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85800" y="6096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85800" y="27432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L  37 38 39 40 41 42 43 44 45 46 47 48 49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lum contrast="10000"/>
          </a:blip>
          <a:srcRect l="10000" r="7949" b="35948"/>
          <a:stretch>
            <a:fillRect/>
          </a:stretch>
        </p:blipFill>
        <p:spPr bwMode="auto">
          <a:xfrm>
            <a:off x="533400" y="990600"/>
            <a:ext cx="79248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Rectangle 5"/>
          <p:cNvSpPr/>
          <p:nvPr/>
        </p:nvSpPr>
        <p:spPr>
          <a:xfrm>
            <a:off x="609600" y="914400"/>
            <a:ext cx="76962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      1   2   3    4   5   6   7   8     9  10  11 12 13 14 15  L   16 17 18 19 20 21 22 23  24  </a:t>
            </a:r>
          </a:p>
        </p:txBody>
      </p:sp>
      <p:sp>
        <p:nvSpPr>
          <p:cNvPr id="7" name="Rectangle 6"/>
          <p:cNvSpPr/>
          <p:nvPr/>
        </p:nvSpPr>
        <p:spPr>
          <a:xfrm>
            <a:off x="609600" y="2743200"/>
            <a:ext cx="792480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b="1" dirty="0">
                <a:solidFill>
                  <a:schemeClr val="bg1"/>
                </a:solidFill>
              </a:rPr>
              <a:t>25 26 27 28 29 30 31 32 33 34 35  36    L    37 38 39 40 41 42 43  44 45 46 47 48 49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462</Words>
  <Application>Microsoft Macintosh PowerPoint</Application>
  <PresentationFormat>On-screen Show (4:3)</PresentationFormat>
  <Paragraphs>100</Paragraphs>
  <Slides>20</Slides>
  <Notes>2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oj</dc:creator>
  <cp:lastModifiedBy>Microsoft Office User</cp:lastModifiedBy>
  <cp:revision>1</cp:revision>
  <dcterms:created xsi:type="dcterms:W3CDTF">2006-08-16T00:00:00Z</dcterms:created>
  <dcterms:modified xsi:type="dcterms:W3CDTF">2023-08-03T14:07:54Z</dcterms:modified>
</cp:coreProperties>
</file>